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6" r:id="rId3"/>
    <p:sldId id="257" r:id="rId4"/>
  </p:sldIdLst>
  <p:sldSz cx="12192000" cy="6858000"/>
  <p:notesSz cx="7099300" cy="102346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9.xlsx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0.xlsx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6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7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8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5!$B$4:$B$13</c:f>
              <c:strCache>
                <c:ptCount val="10"/>
                <c:pt idx="0">
                  <c:v>&lt;24</c:v>
                </c:pt>
                <c:pt idx="1">
                  <c:v>25-29</c:v>
                </c:pt>
                <c:pt idx="2">
                  <c:v>30-34</c:v>
                </c:pt>
                <c:pt idx="3">
                  <c:v>35-39</c:v>
                </c:pt>
                <c:pt idx="4">
                  <c:v>40-44</c:v>
                </c:pt>
                <c:pt idx="5">
                  <c:v>45-49</c:v>
                </c:pt>
                <c:pt idx="6">
                  <c:v>50-54</c:v>
                </c:pt>
                <c:pt idx="7">
                  <c:v>55-60</c:v>
                </c:pt>
                <c:pt idx="8">
                  <c:v>60-64</c:v>
                </c:pt>
                <c:pt idx="9">
                  <c:v>64&lt;</c:v>
                </c:pt>
              </c:strCache>
            </c:strRef>
          </c:cat>
          <c:val>
            <c:numRef>
              <c:f>Sheet5!$D$4:$D$13</c:f>
              <c:numCache>
                <c:formatCode>####.0000</c:formatCode>
                <c:ptCount val="10"/>
                <c:pt idx="0">
                  <c:v>-0.15768536585365742</c:v>
                </c:pt>
                <c:pt idx="1">
                  <c:v>-0.15588854489163972</c:v>
                </c:pt>
                <c:pt idx="2">
                  <c:v>-0.14894666666666606</c:v>
                </c:pt>
                <c:pt idx="3">
                  <c:v>-0.20980102040816181</c:v>
                </c:pt>
                <c:pt idx="4">
                  <c:v>-0.21608823529411625</c:v>
                </c:pt>
                <c:pt idx="5">
                  <c:v>-0.22240692640692586</c:v>
                </c:pt>
                <c:pt idx="6">
                  <c:v>-0.29261279461279516</c:v>
                </c:pt>
                <c:pt idx="7">
                  <c:v>-0.30633841463414557</c:v>
                </c:pt>
                <c:pt idx="8">
                  <c:v>-0.31226241134751748</c:v>
                </c:pt>
                <c:pt idx="9">
                  <c:v>-0.477207547169811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855-437A-B7A4-DF7FABAD31F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65565728"/>
        <c:axId val="465572000"/>
      </c:barChart>
      <c:catAx>
        <c:axId val="4655657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5572000"/>
        <c:crosses val="autoZero"/>
        <c:auto val="1"/>
        <c:lblAlgn val="ctr"/>
        <c:lblOffset val="100"/>
        <c:noMultiLvlLbl val="0"/>
      </c:catAx>
      <c:valAx>
        <c:axId val="465572000"/>
        <c:scaling>
          <c:orientation val="minMax"/>
          <c:min val="-0.5"/>
        </c:scaling>
        <c:delete val="0"/>
        <c:axPos val="l"/>
        <c:numFmt formatCode="#,##0.0_ 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5565728"/>
        <c:crosses val="autoZero"/>
        <c:crossBetween val="between"/>
        <c:majorUnit val="0.1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5!$B$103:$B$112</c:f>
              <c:strCache>
                <c:ptCount val="10"/>
                <c:pt idx="0">
                  <c:v>&lt;24</c:v>
                </c:pt>
                <c:pt idx="1">
                  <c:v>25-29</c:v>
                </c:pt>
                <c:pt idx="2">
                  <c:v>30-34</c:v>
                </c:pt>
                <c:pt idx="3">
                  <c:v>35-39</c:v>
                </c:pt>
                <c:pt idx="4">
                  <c:v>40-44</c:v>
                </c:pt>
                <c:pt idx="5">
                  <c:v>45-49</c:v>
                </c:pt>
                <c:pt idx="6">
                  <c:v>50-54</c:v>
                </c:pt>
                <c:pt idx="7">
                  <c:v>55-60</c:v>
                </c:pt>
                <c:pt idx="8">
                  <c:v>60-64</c:v>
                </c:pt>
                <c:pt idx="9">
                  <c:v>64&lt;</c:v>
                </c:pt>
              </c:strCache>
            </c:strRef>
          </c:cat>
          <c:val>
            <c:numRef>
              <c:f>Sheet5!$D$103:$D$112</c:f>
              <c:numCache>
                <c:formatCode>####.0000</c:formatCode>
                <c:ptCount val="10"/>
                <c:pt idx="0">
                  <c:v>-0.35323170731707282</c:v>
                </c:pt>
                <c:pt idx="1">
                  <c:v>-0.30127863777089836</c:v>
                </c:pt>
                <c:pt idx="2">
                  <c:v>-0.31147333333333399</c:v>
                </c:pt>
                <c:pt idx="3">
                  <c:v>-0.29559693877551063</c:v>
                </c:pt>
                <c:pt idx="4">
                  <c:v>-0.37863235294117481</c:v>
                </c:pt>
                <c:pt idx="5">
                  <c:v>-0.37538528138527932</c:v>
                </c:pt>
                <c:pt idx="6">
                  <c:v>-0.41055387205387101</c:v>
                </c:pt>
                <c:pt idx="7">
                  <c:v>-0.34894817073170759</c:v>
                </c:pt>
                <c:pt idx="8">
                  <c:v>-0.31346808510638341</c:v>
                </c:pt>
                <c:pt idx="9">
                  <c:v>-0.484245283018868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3F4-4B94-897E-19576B6A45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7064360"/>
        <c:axId val="657058872"/>
      </c:barChart>
      <c:catAx>
        <c:axId val="6570643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7058872"/>
        <c:crosses val="autoZero"/>
        <c:auto val="1"/>
        <c:lblAlgn val="ctr"/>
        <c:lblOffset val="100"/>
        <c:noMultiLvlLbl val="0"/>
      </c:catAx>
      <c:valAx>
        <c:axId val="657058872"/>
        <c:scaling>
          <c:orientation val="minMax"/>
          <c:min val="-0.5"/>
        </c:scaling>
        <c:delete val="0"/>
        <c:axPos val="l"/>
        <c:numFmt formatCode="#,##0.0_ 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7064360"/>
        <c:crosses val="autoZero"/>
        <c:crossBetween val="between"/>
        <c:majorUnit val="0.1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5!$B$114:$B$123</c:f>
              <c:strCache>
                <c:ptCount val="10"/>
                <c:pt idx="0">
                  <c:v>&lt;24</c:v>
                </c:pt>
                <c:pt idx="1">
                  <c:v>25-29</c:v>
                </c:pt>
                <c:pt idx="2">
                  <c:v>30-34</c:v>
                </c:pt>
                <c:pt idx="3">
                  <c:v>35-39</c:v>
                </c:pt>
                <c:pt idx="4">
                  <c:v>40-44</c:v>
                </c:pt>
                <c:pt idx="5">
                  <c:v>45-49</c:v>
                </c:pt>
                <c:pt idx="6">
                  <c:v>50-54</c:v>
                </c:pt>
                <c:pt idx="7">
                  <c:v>55-60</c:v>
                </c:pt>
                <c:pt idx="8">
                  <c:v>60-64</c:v>
                </c:pt>
                <c:pt idx="9">
                  <c:v>64&lt;</c:v>
                </c:pt>
              </c:strCache>
            </c:strRef>
          </c:cat>
          <c:val>
            <c:numRef>
              <c:f>Sheet5!$D$114:$D$123</c:f>
              <c:numCache>
                <c:formatCode>####.0000</c:formatCode>
                <c:ptCount val="10"/>
                <c:pt idx="0">
                  <c:v>6.7051219512195212E-2</c:v>
                </c:pt>
                <c:pt idx="1">
                  <c:v>0.15419195046439577</c:v>
                </c:pt>
                <c:pt idx="2">
                  <c:v>0.10889333333333329</c:v>
                </c:pt>
                <c:pt idx="3">
                  <c:v>0.15358673469387685</c:v>
                </c:pt>
                <c:pt idx="4">
                  <c:v>3.6159926470588355E-2</c:v>
                </c:pt>
                <c:pt idx="5">
                  <c:v>-4.3974025974025797E-2</c:v>
                </c:pt>
                <c:pt idx="6">
                  <c:v>-9.242424242424354E-3</c:v>
                </c:pt>
                <c:pt idx="7">
                  <c:v>-4.6722560975609541E-2</c:v>
                </c:pt>
                <c:pt idx="8">
                  <c:v>-2.203546099290777E-2</c:v>
                </c:pt>
                <c:pt idx="9">
                  <c:v>-0.13626415094339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125-41AD-8CDF-4403DBFC38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7064752"/>
        <c:axId val="657062792"/>
      </c:barChart>
      <c:catAx>
        <c:axId val="6570647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7062792"/>
        <c:crosses val="autoZero"/>
        <c:auto val="1"/>
        <c:lblAlgn val="ctr"/>
        <c:lblOffset val="100"/>
        <c:noMultiLvlLbl val="0"/>
      </c:catAx>
      <c:valAx>
        <c:axId val="657062792"/>
        <c:scaling>
          <c:orientation val="minMax"/>
          <c:min val="-0.2"/>
        </c:scaling>
        <c:delete val="0"/>
        <c:axPos val="l"/>
        <c:numFmt formatCode="#,##0.0_ 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7064752"/>
        <c:crosses val="autoZero"/>
        <c:crossBetween val="between"/>
        <c:majorUnit val="0.1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5!$B$15:$B$24</c:f>
              <c:strCache>
                <c:ptCount val="10"/>
                <c:pt idx="0">
                  <c:v>&lt;24</c:v>
                </c:pt>
                <c:pt idx="1">
                  <c:v>25-29</c:v>
                </c:pt>
                <c:pt idx="2">
                  <c:v>30-34</c:v>
                </c:pt>
                <c:pt idx="3">
                  <c:v>35-39</c:v>
                </c:pt>
                <c:pt idx="4">
                  <c:v>40-44</c:v>
                </c:pt>
                <c:pt idx="5">
                  <c:v>45-49</c:v>
                </c:pt>
                <c:pt idx="6">
                  <c:v>50-54</c:v>
                </c:pt>
                <c:pt idx="7">
                  <c:v>55-60</c:v>
                </c:pt>
                <c:pt idx="8">
                  <c:v>60-64</c:v>
                </c:pt>
                <c:pt idx="9">
                  <c:v>64&lt;</c:v>
                </c:pt>
              </c:strCache>
            </c:strRef>
          </c:cat>
          <c:val>
            <c:numRef>
              <c:f>Sheet5!$D$15:$D$24</c:f>
              <c:numCache>
                <c:formatCode>####.0000</c:formatCode>
                <c:ptCount val="10"/>
                <c:pt idx="0">
                  <c:v>-0.21052682926829258</c:v>
                </c:pt>
                <c:pt idx="1">
                  <c:v>-0.19599380804953553</c:v>
                </c:pt>
                <c:pt idx="2">
                  <c:v>-0.19434666666666656</c:v>
                </c:pt>
                <c:pt idx="3">
                  <c:v>-0.19703316326530593</c:v>
                </c:pt>
                <c:pt idx="4">
                  <c:v>-0.22418749999999993</c:v>
                </c:pt>
                <c:pt idx="5">
                  <c:v>-0.25771428571428534</c:v>
                </c:pt>
                <c:pt idx="6">
                  <c:v>-0.26378787878787857</c:v>
                </c:pt>
                <c:pt idx="7">
                  <c:v>-0.2847865853658535</c:v>
                </c:pt>
                <c:pt idx="8">
                  <c:v>-0.33782269503546086</c:v>
                </c:pt>
                <c:pt idx="9">
                  <c:v>-0.351981132075471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2DE-4693-BE9C-6569BA1C54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65568472"/>
        <c:axId val="465568864"/>
      </c:barChart>
      <c:catAx>
        <c:axId val="4655684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5568864"/>
        <c:crosses val="autoZero"/>
        <c:auto val="1"/>
        <c:lblAlgn val="ctr"/>
        <c:lblOffset val="100"/>
        <c:noMultiLvlLbl val="0"/>
      </c:catAx>
      <c:valAx>
        <c:axId val="465568864"/>
        <c:scaling>
          <c:orientation val="minMax"/>
          <c:min val="-0.4"/>
        </c:scaling>
        <c:delete val="0"/>
        <c:axPos val="l"/>
        <c:numFmt formatCode="#,##0.0_ 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5568472"/>
        <c:crosses val="autoZero"/>
        <c:crossBetween val="between"/>
        <c:majorUnit val="0.1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674849439352677"/>
          <c:y val="7.7411107840900578E-2"/>
          <c:w val="0.8418636220353003"/>
          <c:h val="0.8617658788555345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5!$B$26:$B$35</c:f>
              <c:strCache>
                <c:ptCount val="10"/>
                <c:pt idx="0">
                  <c:v>&lt;24</c:v>
                </c:pt>
                <c:pt idx="1">
                  <c:v>25-29</c:v>
                </c:pt>
                <c:pt idx="2">
                  <c:v>30-34</c:v>
                </c:pt>
                <c:pt idx="3">
                  <c:v>35-39</c:v>
                </c:pt>
                <c:pt idx="4">
                  <c:v>40-44</c:v>
                </c:pt>
                <c:pt idx="5">
                  <c:v>45-49</c:v>
                </c:pt>
                <c:pt idx="6">
                  <c:v>50-54</c:v>
                </c:pt>
                <c:pt idx="7">
                  <c:v>55-60</c:v>
                </c:pt>
                <c:pt idx="8">
                  <c:v>60-64</c:v>
                </c:pt>
                <c:pt idx="9">
                  <c:v>64&lt;</c:v>
                </c:pt>
              </c:strCache>
            </c:strRef>
          </c:cat>
          <c:val>
            <c:numRef>
              <c:f>Sheet5!$D$26:$D$35</c:f>
              <c:numCache>
                <c:formatCode>####.0000</c:formatCode>
                <c:ptCount val="10"/>
                <c:pt idx="0">
                  <c:v>0.22064878048780459</c:v>
                </c:pt>
                <c:pt idx="1">
                  <c:v>0.30980804953560354</c:v>
                </c:pt>
                <c:pt idx="2">
                  <c:v>0.3136766666666666</c:v>
                </c:pt>
                <c:pt idx="3">
                  <c:v>0.2065331632653058</c:v>
                </c:pt>
                <c:pt idx="4">
                  <c:v>0.1652205882352937</c:v>
                </c:pt>
                <c:pt idx="5">
                  <c:v>8.3568542568541973E-2</c:v>
                </c:pt>
                <c:pt idx="6">
                  <c:v>9.2846801346800872E-2</c:v>
                </c:pt>
                <c:pt idx="7">
                  <c:v>5.099085365853611E-2</c:v>
                </c:pt>
                <c:pt idx="8">
                  <c:v>9.588652482269585E-3</c:v>
                </c:pt>
                <c:pt idx="9">
                  <c:v>-8.305660377358491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78D-4D17-87AB-3E99F87994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65564160"/>
        <c:axId val="465564944"/>
      </c:barChart>
      <c:catAx>
        <c:axId val="465564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5564944"/>
        <c:crosses val="autoZero"/>
        <c:auto val="1"/>
        <c:lblAlgn val="ctr"/>
        <c:lblOffset val="100"/>
        <c:noMultiLvlLbl val="0"/>
      </c:catAx>
      <c:valAx>
        <c:axId val="465564944"/>
        <c:scaling>
          <c:orientation val="minMax"/>
          <c:min val="-0.2"/>
        </c:scaling>
        <c:delete val="0"/>
        <c:axPos val="l"/>
        <c:numFmt formatCode="#,##0.0_ 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5564160"/>
        <c:crosses val="autoZero"/>
        <c:crossBetween val="between"/>
        <c:majorUnit val="0.1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32234675360916"/>
          <c:y val="0.11724402290292348"/>
          <c:w val="0.84272721109778037"/>
          <c:h val="0.7645012713811795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5!$B$37:$B$46</c:f>
              <c:strCache>
                <c:ptCount val="10"/>
                <c:pt idx="0">
                  <c:v>&lt;24</c:v>
                </c:pt>
                <c:pt idx="1">
                  <c:v>25-29</c:v>
                </c:pt>
                <c:pt idx="2">
                  <c:v>30-34</c:v>
                </c:pt>
                <c:pt idx="3">
                  <c:v>35-39</c:v>
                </c:pt>
                <c:pt idx="4">
                  <c:v>40-44</c:v>
                </c:pt>
                <c:pt idx="5">
                  <c:v>45-49</c:v>
                </c:pt>
                <c:pt idx="6">
                  <c:v>50-54</c:v>
                </c:pt>
                <c:pt idx="7">
                  <c:v>55-60</c:v>
                </c:pt>
                <c:pt idx="8">
                  <c:v>60-64</c:v>
                </c:pt>
                <c:pt idx="9">
                  <c:v>64&lt;</c:v>
                </c:pt>
              </c:strCache>
            </c:strRef>
          </c:cat>
          <c:val>
            <c:numRef>
              <c:f>Sheet5!$D$37:$D$46</c:f>
              <c:numCache>
                <c:formatCode>####.0000</c:formatCode>
                <c:ptCount val="10"/>
                <c:pt idx="0">
                  <c:v>1.0921951219512194E-2</c:v>
                </c:pt>
                <c:pt idx="1">
                  <c:v>2.0216718266253871E-3</c:v>
                </c:pt>
                <c:pt idx="2">
                  <c:v>1.4033333333333333E-2</c:v>
                </c:pt>
                <c:pt idx="3">
                  <c:v>2.3507653061224491E-2</c:v>
                </c:pt>
                <c:pt idx="4">
                  <c:v>1.9593749999999997E-2</c:v>
                </c:pt>
                <c:pt idx="5">
                  <c:v>3.0493506493506496E-2</c:v>
                </c:pt>
                <c:pt idx="6">
                  <c:v>3.015488215488216E-2</c:v>
                </c:pt>
                <c:pt idx="7">
                  <c:v>3.4131097560975612E-2</c:v>
                </c:pt>
                <c:pt idx="8">
                  <c:v>7.9397163120567382E-2</c:v>
                </c:pt>
                <c:pt idx="9" formatCode="###0.000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219-4D3C-AE72-9CEF051C15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65573568"/>
        <c:axId val="465566512"/>
      </c:barChart>
      <c:catAx>
        <c:axId val="465573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5566512"/>
        <c:crosses val="autoZero"/>
        <c:auto val="1"/>
        <c:lblAlgn val="ctr"/>
        <c:lblOffset val="100"/>
        <c:noMultiLvlLbl val="0"/>
      </c:catAx>
      <c:valAx>
        <c:axId val="465566512"/>
        <c:scaling>
          <c:orientation val="minMax"/>
          <c:min val="0"/>
        </c:scaling>
        <c:delete val="0"/>
        <c:axPos val="l"/>
        <c:numFmt formatCode="#,##0.0_ 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5573568"/>
        <c:crosses val="autoZero"/>
        <c:crossBetween val="between"/>
        <c:majorUnit val="5.000000000000001E-2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5!$B$48:$B$57</c:f>
              <c:strCache>
                <c:ptCount val="10"/>
                <c:pt idx="0">
                  <c:v>&lt;24</c:v>
                </c:pt>
                <c:pt idx="1">
                  <c:v>25-29</c:v>
                </c:pt>
                <c:pt idx="2">
                  <c:v>30-34</c:v>
                </c:pt>
                <c:pt idx="3">
                  <c:v>35-39</c:v>
                </c:pt>
                <c:pt idx="4">
                  <c:v>40-44</c:v>
                </c:pt>
                <c:pt idx="5">
                  <c:v>45-49</c:v>
                </c:pt>
                <c:pt idx="6">
                  <c:v>50-54</c:v>
                </c:pt>
                <c:pt idx="7">
                  <c:v>55-60</c:v>
                </c:pt>
                <c:pt idx="8">
                  <c:v>60-64</c:v>
                </c:pt>
                <c:pt idx="9">
                  <c:v>64&lt;</c:v>
                </c:pt>
              </c:strCache>
            </c:strRef>
          </c:cat>
          <c:val>
            <c:numRef>
              <c:f>Sheet5!$D$48:$D$57</c:f>
              <c:numCache>
                <c:formatCode>####.0000</c:formatCode>
                <c:ptCount val="10"/>
                <c:pt idx="0">
                  <c:v>7.2897560975610134E-2</c:v>
                </c:pt>
                <c:pt idx="1">
                  <c:v>0.12008978328173342</c:v>
                </c:pt>
                <c:pt idx="2">
                  <c:v>0.11893000000000001</c:v>
                </c:pt>
                <c:pt idx="3">
                  <c:v>0.18119897959183565</c:v>
                </c:pt>
                <c:pt idx="4">
                  <c:v>0.17469301470588325</c:v>
                </c:pt>
                <c:pt idx="5">
                  <c:v>0.25078066378066527</c:v>
                </c:pt>
                <c:pt idx="6">
                  <c:v>0.33214141414141551</c:v>
                </c:pt>
                <c:pt idx="7">
                  <c:v>0.31407317073170787</c:v>
                </c:pt>
                <c:pt idx="8">
                  <c:v>0.38263829787234005</c:v>
                </c:pt>
                <c:pt idx="9">
                  <c:v>0.352264150943396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CBF-4BD9-BBCB-18082F167B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65566904"/>
        <c:axId val="465572392"/>
      </c:barChart>
      <c:catAx>
        <c:axId val="4655669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5572392"/>
        <c:crosses val="autoZero"/>
        <c:auto val="1"/>
        <c:lblAlgn val="ctr"/>
        <c:lblOffset val="100"/>
        <c:noMultiLvlLbl val="0"/>
      </c:catAx>
      <c:valAx>
        <c:axId val="465572392"/>
        <c:scaling>
          <c:orientation val="minMax"/>
          <c:min val="0"/>
        </c:scaling>
        <c:delete val="0"/>
        <c:axPos val="l"/>
        <c:numFmt formatCode="#,##0.0_ 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5566904"/>
        <c:crosses val="autoZero"/>
        <c:crossBetween val="between"/>
        <c:majorUnit val="0.1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5!$B$59:$B$68</c:f>
              <c:strCache>
                <c:ptCount val="10"/>
                <c:pt idx="0">
                  <c:v>&lt;24</c:v>
                </c:pt>
                <c:pt idx="1">
                  <c:v>25-29</c:v>
                </c:pt>
                <c:pt idx="2">
                  <c:v>30-34</c:v>
                </c:pt>
                <c:pt idx="3">
                  <c:v>35-39</c:v>
                </c:pt>
                <c:pt idx="4">
                  <c:v>40-44</c:v>
                </c:pt>
                <c:pt idx="5">
                  <c:v>45-49</c:v>
                </c:pt>
                <c:pt idx="6">
                  <c:v>50-54</c:v>
                </c:pt>
                <c:pt idx="7">
                  <c:v>55-60</c:v>
                </c:pt>
                <c:pt idx="8">
                  <c:v>60-64</c:v>
                </c:pt>
                <c:pt idx="9">
                  <c:v>64&lt;</c:v>
                </c:pt>
              </c:strCache>
            </c:strRef>
          </c:cat>
          <c:val>
            <c:numRef>
              <c:f>Sheet5!$D$59:$D$68</c:f>
              <c:numCache>
                <c:formatCode>####.0000</c:formatCode>
                <c:ptCount val="10"/>
                <c:pt idx="0">
                  <c:v>0.15356341463414638</c:v>
                </c:pt>
                <c:pt idx="1">
                  <c:v>0.20886068111455106</c:v>
                </c:pt>
                <c:pt idx="2">
                  <c:v>0.15090333333333333</c:v>
                </c:pt>
                <c:pt idx="3">
                  <c:v>0.10413775510204092</c:v>
                </c:pt>
                <c:pt idx="4">
                  <c:v>6.579227941176484E-2</c:v>
                </c:pt>
                <c:pt idx="5">
                  <c:v>1.0490620490620486E-3</c:v>
                </c:pt>
                <c:pt idx="6">
                  <c:v>2.2104377104377154E-2</c:v>
                </c:pt>
                <c:pt idx="7">
                  <c:v>6.1603658536585559E-2</c:v>
                </c:pt>
                <c:pt idx="8">
                  <c:v>0.17804255319148946</c:v>
                </c:pt>
                <c:pt idx="9">
                  <c:v>6.888679245283020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2E1-4F0D-87CD-455D8C97F7D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65570040"/>
        <c:axId val="465570432"/>
      </c:barChart>
      <c:catAx>
        <c:axId val="4655700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5570432"/>
        <c:crosses val="autoZero"/>
        <c:auto val="1"/>
        <c:lblAlgn val="ctr"/>
        <c:lblOffset val="100"/>
        <c:noMultiLvlLbl val="0"/>
      </c:catAx>
      <c:valAx>
        <c:axId val="465570432"/>
        <c:scaling>
          <c:orientation val="minMax"/>
          <c:min val="0"/>
        </c:scaling>
        <c:delete val="0"/>
        <c:axPos val="l"/>
        <c:numFmt formatCode="#,##0.0_ 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5570040"/>
        <c:crosses val="autoZero"/>
        <c:crossBetween val="between"/>
        <c:majorUnit val="0.1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5!$B$70:$B$79</c:f>
              <c:strCache>
                <c:ptCount val="10"/>
                <c:pt idx="0">
                  <c:v>&lt;24</c:v>
                </c:pt>
                <c:pt idx="1">
                  <c:v>25-29</c:v>
                </c:pt>
                <c:pt idx="2">
                  <c:v>30-34</c:v>
                </c:pt>
                <c:pt idx="3">
                  <c:v>35-39</c:v>
                </c:pt>
                <c:pt idx="4">
                  <c:v>40-44</c:v>
                </c:pt>
                <c:pt idx="5">
                  <c:v>45-49</c:v>
                </c:pt>
                <c:pt idx="6">
                  <c:v>50-54</c:v>
                </c:pt>
                <c:pt idx="7">
                  <c:v>55-60</c:v>
                </c:pt>
                <c:pt idx="8">
                  <c:v>60-64</c:v>
                </c:pt>
                <c:pt idx="9">
                  <c:v>64&lt;</c:v>
                </c:pt>
              </c:strCache>
            </c:strRef>
          </c:cat>
          <c:val>
            <c:numRef>
              <c:f>Sheet5!$D$70:$D$79</c:f>
              <c:numCache>
                <c:formatCode>####.0000</c:formatCode>
                <c:ptCount val="10"/>
                <c:pt idx="0">
                  <c:v>0.15030243902438967</c:v>
                </c:pt>
                <c:pt idx="1">
                  <c:v>0.14491331269349855</c:v>
                </c:pt>
                <c:pt idx="2">
                  <c:v>0.10515666666666711</c:v>
                </c:pt>
                <c:pt idx="3">
                  <c:v>7.9201530612245538E-2</c:v>
                </c:pt>
                <c:pt idx="4">
                  <c:v>0.1012867647058818</c:v>
                </c:pt>
                <c:pt idx="5">
                  <c:v>7.3636363636363084E-3</c:v>
                </c:pt>
                <c:pt idx="6">
                  <c:v>7.6525252525252191E-2</c:v>
                </c:pt>
                <c:pt idx="7">
                  <c:v>5.4939024390243726E-3</c:v>
                </c:pt>
                <c:pt idx="8">
                  <c:v>8.877304964539004E-2</c:v>
                </c:pt>
                <c:pt idx="9">
                  <c:v>-2.779245283018869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110-48A9-935B-C7E498A0B0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65574352"/>
        <c:axId val="465562592"/>
      </c:barChart>
      <c:catAx>
        <c:axId val="4655743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5562592"/>
        <c:crosses val="autoZero"/>
        <c:auto val="1"/>
        <c:lblAlgn val="ctr"/>
        <c:lblOffset val="100"/>
        <c:noMultiLvlLbl val="0"/>
      </c:catAx>
      <c:valAx>
        <c:axId val="465562592"/>
        <c:scaling>
          <c:orientation val="minMax"/>
          <c:min val="-0.1"/>
        </c:scaling>
        <c:delete val="0"/>
        <c:axPos val="l"/>
        <c:numFmt formatCode="#,##0.0_ 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5574352"/>
        <c:crosses val="autoZero"/>
        <c:crossBetween val="between"/>
        <c:majorUnit val="0.1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5!$B$81:$B$90</c:f>
              <c:strCache>
                <c:ptCount val="10"/>
                <c:pt idx="0">
                  <c:v>&lt;24</c:v>
                </c:pt>
                <c:pt idx="1">
                  <c:v>25-29</c:v>
                </c:pt>
                <c:pt idx="2">
                  <c:v>30-34</c:v>
                </c:pt>
                <c:pt idx="3">
                  <c:v>35-39</c:v>
                </c:pt>
                <c:pt idx="4">
                  <c:v>40-44</c:v>
                </c:pt>
                <c:pt idx="5">
                  <c:v>45-49</c:v>
                </c:pt>
                <c:pt idx="6">
                  <c:v>50-54</c:v>
                </c:pt>
                <c:pt idx="7">
                  <c:v>55-60</c:v>
                </c:pt>
                <c:pt idx="8">
                  <c:v>60-64</c:v>
                </c:pt>
                <c:pt idx="9">
                  <c:v>64&lt;</c:v>
                </c:pt>
              </c:strCache>
            </c:strRef>
          </c:cat>
          <c:val>
            <c:numRef>
              <c:f>Sheet5!$D$81:$D$90</c:f>
              <c:numCache>
                <c:formatCode>####.0000</c:formatCode>
                <c:ptCount val="10"/>
                <c:pt idx="0">
                  <c:v>4.0943902439024286E-2</c:v>
                </c:pt>
                <c:pt idx="1">
                  <c:v>5.4622291021670918E-2</c:v>
                </c:pt>
                <c:pt idx="2">
                  <c:v>5.7446666666666493E-2</c:v>
                </c:pt>
                <c:pt idx="3">
                  <c:v>6.188265306122398E-2</c:v>
                </c:pt>
                <c:pt idx="4">
                  <c:v>5.9676470588234387E-2</c:v>
                </c:pt>
                <c:pt idx="5">
                  <c:v>4.5220779220778724E-2</c:v>
                </c:pt>
                <c:pt idx="6">
                  <c:v>6.9478114478114292E-2</c:v>
                </c:pt>
                <c:pt idx="7">
                  <c:v>7.1271341463414073E-2</c:v>
                </c:pt>
                <c:pt idx="8">
                  <c:v>0.11353900709219854</c:v>
                </c:pt>
                <c:pt idx="9">
                  <c:v>0.10300000000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D30-4CE9-84E0-002880EBD2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7059264"/>
        <c:axId val="657069848"/>
      </c:barChart>
      <c:catAx>
        <c:axId val="6570592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7069848"/>
        <c:crosses val="autoZero"/>
        <c:auto val="1"/>
        <c:lblAlgn val="ctr"/>
        <c:lblOffset val="100"/>
        <c:noMultiLvlLbl val="0"/>
      </c:catAx>
      <c:valAx>
        <c:axId val="657069848"/>
        <c:scaling>
          <c:orientation val="minMax"/>
          <c:max val="0.15000000000000002"/>
          <c:min val="0"/>
        </c:scaling>
        <c:delete val="0"/>
        <c:axPos val="l"/>
        <c:numFmt formatCode="#,##0.00_ 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7059264"/>
        <c:crosses val="autoZero"/>
        <c:crossBetween val="between"/>
        <c:majorUnit val="5.000000000000001E-2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5!$B$92:$B$101</c:f>
              <c:strCache>
                <c:ptCount val="10"/>
                <c:pt idx="0">
                  <c:v>&lt;24</c:v>
                </c:pt>
                <c:pt idx="1">
                  <c:v>25-29</c:v>
                </c:pt>
                <c:pt idx="2">
                  <c:v>30-34</c:v>
                </c:pt>
                <c:pt idx="3">
                  <c:v>35-39</c:v>
                </c:pt>
                <c:pt idx="4">
                  <c:v>40-44</c:v>
                </c:pt>
                <c:pt idx="5">
                  <c:v>45-49</c:v>
                </c:pt>
                <c:pt idx="6">
                  <c:v>50-54</c:v>
                </c:pt>
                <c:pt idx="7">
                  <c:v>55-60</c:v>
                </c:pt>
                <c:pt idx="8">
                  <c:v>60-64</c:v>
                </c:pt>
                <c:pt idx="9">
                  <c:v>64&lt;</c:v>
                </c:pt>
              </c:strCache>
            </c:strRef>
          </c:cat>
          <c:val>
            <c:numRef>
              <c:f>Sheet5!$D$92:$D$101</c:f>
              <c:numCache>
                <c:formatCode>####.0000</c:formatCode>
                <c:ptCount val="10"/>
                <c:pt idx="0">
                  <c:v>1.4390243902439025E-2</c:v>
                </c:pt>
                <c:pt idx="1">
                  <c:v>9.1331269349845205E-3</c:v>
                </c:pt>
                <c:pt idx="2">
                  <c:v>9.8333333333333345E-3</c:v>
                </c:pt>
                <c:pt idx="3">
                  <c:v>2.3127551020408161E-2</c:v>
                </c:pt>
                <c:pt idx="4">
                  <c:v>1.4549632352941176E-2</c:v>
                </c:pt>
                <c:pt idx="5">
                  <c:v>6.541125541125542E-3</c:v>
                </c:pt>
                <c:pt idx="6">
                  <c:v>1.7927609427609428E-2</c:v>
                </c:pt>
                <c:pt idx="7">
                  <c:v>4.1676829268292685E-3</c:v>
                </c:pt>
                <c:pt idx="8" formatCode="###0.0000">
                  <c:v>0</c:v>
                </c:pt>
                <c:pt idx="9" formatCode="###0.000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857-46C0-8BA8-2C89DA4865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7061224"/>
        <c:axId val="657061616"/>
      </c:barChart>
      <c:catAx>
        <c:axId val="6570612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7061616"/>
        <c:crosses val="autoZero"/>
        <c:auto val="1"/>
        <c:lblAlgn val="ctr"/>
        <c:lblOffset val="100"/>
        <c:noMultiLvlLbl val="0"/>
      </c:catAx>
      <c:valAx>
        <c:axId val="657061616"/>
        <c:scaling>
          <c:orientation val="minMax"/>
          <c:max val="5.000000000000001E-2"/>
          <c:min val="0"/>
        </c:scaling>
        <c:delete val="0"/>
        <c:axPos val="l"/>
        <c:numFmt formatCode="#,##0.00_ 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7061224"/>
        <c:crosses val="autoZero"/>
        <c:crossBetween val="between"/>
        <c:majorUnit val="1.0000000000000002E-2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FC6E9-A827-4001-B6EE-6B9BAB91D4E6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D1EB-E505-4C9A-90BE-BFC10CAA8B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20992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FC6E9-A827-4001-B6EE-6B9BAB91D4E6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D1EB-E505-4C9A-90BE-BFC10CAA8B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11689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FC6E9-A827-4001-B6EE-6B9BAB91D4E6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D1EB-E505-4C9A-90BE-BFC10CAA8B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42892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FC6E9-A827-4001-B6EE-6B9BAB91D4E6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D1EB-E505-4C9A-90BE-BFC10CAA8B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45138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FC6E9-A827-4001-B6EE-6B9BAB91D4E6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D1EB-E505-4C9A-90BE-BFC10CAA8B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4570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FC6E9-A827-4001-B6EE-6B9BAB91D4E6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D1EB-E505-4C9A-90BE-BFC10CAA8B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24417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FC6E9-A827-4001-B6EE-6B9BAB91D4E6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D1EB-E505-4C9A-90BE-BFC10CAA8B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20893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FC6E9-A827-4001-B6EE-6B9BAB91D4E6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D1EB-E505-4C9A-90BE-BFC10CAA8B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7522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FC6E9-A827-4001-B6EE-6B9BAB91D4E6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D1EB-E505-4C9A-90BE-BFC10CAA8B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67580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FC6E9-A827-4001-B6EE-6B9BAB91D4E6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D1EB-E505-4C9A-90BE-BFC10CAA8B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6321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FC6E9-A827-4001-B6EE-6B9BAB91D4E6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D1EB-E505-4C9A-90BE-BFC10CAA8B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53887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4FC6E9-A827-4001-B6EE-6B9BAB91D4E6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F2D1EB-E505-4C9A-90BE-BFC10CAA8B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00208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1.xml"/><Relationship Id="rId5" Type="http://schemas.openxmlformats.org/officeDocument/2006/relationships/chart" Target="../charts/chart10.xml"/><Relationship Id="rId4" Type="http://schemas.openxmlformats.org/officeDocument/2006/relationships/chart" Target="../charts/chart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1"/>
          <p:cNvSpPr txBox="1"/>
          <p:nvPr/>
        </p:nvSpPr>
        <p:spPr>
          <a:xfrm>
            <a:off x="4556956" y="3136613"/>
            <a:ext cx="307808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3200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kumimoji="1" lang="ja-JP" altLang="en-US" sz="3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3200" dirty="0" smtClean="0">
                <a:latin typeface="Arial" panose="020B0604020202020204" pitchFamily="34" charset="0"/>
                <a:cs typeface="Arial" panose="020B0604020202020204" pitchFamily="34" charset="0"/>
              </a:rPr>
              <a:t>file 3</a:t>
            </a:r>
            <a:endParaRPr kumimoji="1" lang="ja-JP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37793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33903901"/>
              </p:ext>
            </p:extLst>
          </p:nvPr>
        </p:nvGraphicFramePr>
        <p:xfrm>
          <a:off x="500200" y="497772"/>
          <a:ext cx="3413662" cy="25547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62002827"/>
              </p:ext>
            </p:extLst>
          </p:nvPr>
        </p:nvGraphicFramePr>
        <p:xfrm>
          <a:off x="4396520" y="492056"/>
          <a:ext cx="3409945" cy="25604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3837659"/>
              </p:ext>
            </p:extLst>
          </p:nvPr>
        </p:nvGraphicFramePr>
        <p:xfrm>
          <a:off x="8126813" y="582055"/>
          <a:ext cx="3403745" cy="24421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0" name="グラフ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62490565"/>
              </p:ext>
            </p:extLst>
          </p:nvPr>
        </p:nvGraphicFramePr>
        <p:xfrm>
          <a:off x="553851" y="3407559"/>
          <a:ext cx="3371567" cy="27718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1" name="グラフ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24081883"/>
              </p:ext>
            </p:extLst>
          </p:nvPr>
        </p:nvGraphicFramePr>
        <p:xfrm>
          <a:off x="4533345" y="3548586"/>
          <a:ext cx="3305832" cy="25513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2" name="グラフ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16371983"/>
              </p:ext>
            </p:extLst>
          </p:nvPr>
        </p:nvGraphicFramePr>
        <p:xfrm>
          <a:off x="8218471" y="3590389"/>
          <a:ext cx="3412918" cy="24812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3" name="テキスト ボックス 12"/>
          <p:cNvSpPr txBox="1"/>
          <p:nvPr/>
        </p:nvSpPr>
        <p:spPr>
          <a:xfrm>
            <a:off x="83254" y="172164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4066270" y="181945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7956020" y="106904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191388" y="3148476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4242892" y="3178880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8126813" y="3120157"/>
            <a:ext cx="51167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 rot="16200000">
            <a:off x="87594" y="1732106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bilit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2720384" y="266228"/>
            <a:ext cx="8915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ge grou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10644648" y="6073594"/>
            <a:ext cx="8915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ge grou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6777424" y="6034466"/>
            <a:ext cx="8915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ge grou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2942242" y="6100670"/>
            <a:ext cx="8915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ge grou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6608662" y="168704"/>
            <a:ext cx="8915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ge grou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10354045" y="2439018"/>
            <a:ext cx="8915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ge grou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 rot="16200000">
            <a:off x="7852933" y="4733428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bilit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 rot="16200000">
            <a:off x="4091403" y="4756442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bilit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 rot="16200000">
            <a:off x="213998" y="4685775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bilit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 rot="16200000">
            <a:off x="7777575" y="1610283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bilit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 rot="16200000">
            <a:off x="4007758" y="1664613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bilit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2915600" y="3052490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/>
              <a:t>P&lt;0.001</a:t>
            </a:r>
            <a:endParaRPr lang="ja-JP" altLang="en-US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6993432" y="3052490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/>
              <a:t>P&lt;0.001</a:t>
            </a:r>
            <a:endParaRPr lang="ja-JP" altLang="en-US" dirty="0"/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10611714" y="2983739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/>
              <a:t>P&lt;0.001</a:t>
            </a:r>
            <a:endParaRPr lang="ja-JP" altLang="en-US" dirty="0"/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3056320" y="6350593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 smtClean="0"/>
              <a:t>P=0.069</a:t>
            </a:r>
            <a:endParaRPr lang="ja-JP" altLang="en-US" dirty="0"/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6908871" y="6292099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/>
              <a:t>P&lt;0.001</a:t>
            </a:r>
            <a:endParaRPr lang="ja-JP" altLang="en-US" dirty="0"/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10749267" y="6326155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/>
              <a:t>P&lt;0.001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9193954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09024347"/>
              </p:ext>
            </p:extLst>
          </p:nvPr>
        </p:nvGraphicFramePr>
        <p:xfrm>
          <a:off x="677470" y="432524"/>
          <a:ext cx="3415872" cy="24574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39761449"/>
              </p:ext>
            </p:extLst>
          </p:nvPr>
        </p:nvGraphicFramePr>
        <p:xfrm>
          <a:off x="4534402" y="377622"/>
          <a:ext cx="3424135" cy="26430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グラフ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26073762"/>
              </p:ext>
            </p:extLst>
          </p:nvPr>
        </p:nvGraphicFramePr>
        <p:xfrm>
          <a:off x="8436569" y="441041"/>
          <a:ext cx="3451200" cy="26578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82023904"/>
              </p:ext>
            </p:extLst>
          </p:nvPr>
        </p:nvGraphicFramePr>
        <p:xfrm>
          <a:off x="642115" y="3630847"/>
          <a:ext cx="3399757" cy="26313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グラフ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84063390"/>
              </p:ext>
            </p:extLst>
          </p:nvPr>
        </p:nvGraphicFramePr>
        <p:xfrm>
          <a:off x="4534402" y="3677924"/>
          <a:ext cx="3451428" cy="23987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0" name="テキスト ボックス 9"/>
          <p:cNvSpPr txBox="1"/>
          <p:nvPr/>
        </p:nvSpPr>
        <p:spPr>
          <a:xfrm>
            <a:off x="357468" y="152337"/>
            <a:ext cx="5533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165497" y="75132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8187039" y="82391"/>
            <a:ext cx="5661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 I )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413573" y="3207258"/>
            <a:ext cx="4972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J)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4192065" y="3216902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K)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6623304" y="5156839"/>
            <a:ext cx="8915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ge grou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066108" y="3385391"/>
            <a:ext cx="8915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ge grou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2872654" y="2260159"/>
            <a:ext cx="8915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ge grou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6975093" y="2909883"/>
            <a:ext cx="8915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ge grou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0939410" y="2998926"/>
            <a:ext cx="8915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ge grou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 rot="16200000">
            <a:off x="4123643" y="4420242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bilit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 rot="16200000">
            <a:off x="8001354" y="1522749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bilit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 rot="16200000">
            <a:off x="4099187" y="1451472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bilit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 rot="16200000">
            <a:off x="320380" y="1582710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bilit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 rot="16200000">
            <a:off x="289195" y="4887592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bilit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7106540" y="6113349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/>
              <a:t>P&lt;0.001</a:t>
            </a:r>
            <a:endParaRPr lang="ja-JP" altLang="en-US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7066946" y="3204738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 smtClean="0"/>
              <a:t>P=0.780</a:t>
            </a:r>
            <a:endParaRPr lang="ja-JP" altLang="en-US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1005133" y="3262308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 smtClean="0"/>
              <a:t>P=0.515</a:t>
            </a:r>
            <a:endParaRPr lang="ja-JP" altLang="en-US" dirty="0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3323132" y="6262179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 smtClean="0"/>
              <a:t>P=0.041</a:t>
            </a:r>
            <a:endParaRPr lang="ja-JP" altLang="en-US" dirty="0"/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3167754" y="2921470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/>
              <a:t>P&lt;0.001</a:t>
            </a:r>
            <a:endParaRPr lang="ja-JP" altLang="en-US" dirty="0"/>
          </a:p>
        </p:txBody>
      </p:sp>
      <p:sp>
        <p:nvSpPr>
          <p:cNvPr id="2" name="正方形/長方形 1"/>
          <p:cNvSpPr/>
          <p:nvPr/>
        </p:nvSpPr>
        <p:spPr>
          <a:xfrm>
            <a:off x="9727188" y="6115368"/>
            <a:ext cx="11849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S2 Figure</a:t>
            </a:r>
            <a:endParaRPr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74423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8</TotalTime>
  <Words>82</Words>
  <Application>Microsoft Office PowerPoint</Application>
  <PresentationFormat>ワイド画面</PresentationFormat>
  <Paragraphs>46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野村 義明</dc:creator>
  <cp:lastModifiedBy>野村 義明</cp:lastModifiedBy>
  <cp:revision>16</cp:revision>
  <cp:lastPrinted>2019-11-25T08:19:10Z</cp:lastPrinted>
  <dcterms:created xsi:type="dcterms:W3CDTF">2019-10-11T02:16:00Z</dcterms:created>
  <dcterms:modified xsi:type="dcterms:W3CDTF">2020-06-06T09:03:33Z</dcterms:modified>
</cp:coreProperties>
</file>